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4"/>
  </p:notesMasterIdLst>
  <p:sldIdLst>
    <p:sldId id="259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31900"/>
    <a:srgbClr val="034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09"/>
    <p:restoredTop sz="79287"/>
  </p:normalViewPr>
  <p:slideViewPr>
    <p:cSldViewPr snapToGrid="0" snapToObjects="1" showGuides="1">
      <p:cViewPr varScale="1">
        <p:scale>
          <a:sx n="89" d="100"/>
          <a:sy n="89" d="100"/>
        </p:scale>
        <p:origin x="2592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9EFC9D-5C9E-AA47-9441-C16B81334170}" type="datetimeFigureOut">
              <a:rPr lang="en-US" smtClean="0"/>
              <a:t>4/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76E735-5D82-D741-8505-AF6B9EE58B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859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CA" sz="1200" b="1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. Correlation between CNS-specific</a:t>
            </a:r>
            <a:r>
              <a:rPr lang="en-CA" sz="1200" b="1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CA" sz="1200" b="1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gression-free survival and overall survival in the cohort.</a:t>
            </a:r>
            <a:r>
              <a:rPr lang="en-CA" sz="1200" b="1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CA" sz="1200" b="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Correlation between overall survival and CNS-specific progression in</a:t>
            </a:r>
            <a:r>
              <a:rPr lang="en-CA" sz="1200" b="0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patients with documented CNS-specific progression. (B) </a:t>
            </a:r>
            <a:r>
              <a:rPr lang="en-CA" sz="1200" b="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lation between overall survival and CNS-specific progression in</a:t>
            </a:r>
            <a:r>
              <a:rPr lang="en-CA" sz="1200" b="0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patients with documented CNS-specific progression and death. (C) </a:t>
            </a:r>
            <a:r>
              <a:rPr lang="en-CA" sz="1200" b="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lation between overall survival and CNS-specific progression in</a:t>
            </a:r>
            <a:r>
              <a:rPr lang="en-CA" sz="1200" b="0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patients with progression caused by causes other than death. (D) </a:t>
            </a:r>
            <a:r>
              <a:rPr lang="en-CA" sz="1200" b="0" kern="120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lation between overall survival and CNS-specific progression in</a:t>
            </a:r>
            <a:r>
              <a:rPr lang="en-CA" sz="1200" b="0" kern="1200" baseline="0" noProof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l patients with progression caused by causes other than death and who had documented death. </a:t>
            </a:r>
            <a:r>
              <a:rPr lang="en-CA" dirty="0">
                <a:latin typeface="Arial" charset="0"/>
                <a:ea typeface="Arial" charset="0"/>
                <a:cs typeface="Arial" charset="0"/>
              </a:rPr>
              <a:t>P-value calculated by linear regression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sz="1200" kern="1200" noProof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76E735-5D82-D741-8505-AF6B9EE58B6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6284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CA" sz="1200" kern="1200" noProof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776E735-5D82-D741-8505-AF6B9EE58B6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9839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2A1E76-EC25-E34B-8C8B-F3E280FAB999}" type="datetimeFigureOut">
              <a:rPr lang="en-US" smtClean="0"/>
              <a:t>4/6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D3C70-E5D7-6F49-87C6-F35B046B3D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176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Box 105">
            <a:extLst>
              <a:ext uri="{FF2B5EF4-FFF2-40B4-BE49-F238E27FC236}">
                <a16:creationId xmlns:a16="http://schemas.microsoft.com/office/drawing/2014/main" id="{CFA81D4E-D03C-D54E-8EA9-D2F3AB806004}"/>
              </a:ext>
            </a:extLst>
          </p:cNvPr>
          <p:cNvSpPr txBox="1"/>
          <p:nvPr/>
        </p:nvSpPr>
        <p:spPr>
          <a:xfrm>
            <a:off x="5337233" y="6537305"/>
            <a:ext cx="38443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Lazaratos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6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pic>
        <p:nvPicPr>
          <p:cNvPr id="119" name="Picture 118"/>
          <p:cNvPicPr>
            <a:picLocks noChangeAspect="1"/>
          </p:cNvPicPr>
          <p:nvPr/>
        </p:nvPicPr>
        <p:blipFill rotWithShape="1">
          <a:blip r:embed="rId3"/>
          <a:srcRect l="9643" t="6763" b="9356"/>
          <a:stretch/>
        </p:blipFill>
        <p:spPr>
          <a:xfrm>
            <a:off x="1130409" y="116054"/>
            <a:ext cx="3232134" cy="2692919"/>
          </a:xfrm>
          <a:prstGeom prst="rect">
            <a:avLst/>
          </a:prstGeom>
        </p:spPr>
      </p:pic>
      <p:sp>
        <p:nvSpPr>
          <p:cNvPr id="120" name="TextBox 119">
            <a:extLst>
              <a:ext uri="{FF2B5EF4-FFF2-40B4-BE49-F238E27FC236}">
                <a16:creationId xmlns:a16="http://schemas.microsoft.com/office/drawing/2014/main" id="{D6E825D7-E3CC-9D06-28FB-2D55C6F54C14}"/>
              </a:ext>
            </a:extLst>
          </p:cNvPr>
          <p:cNvSpPr txBox="1"/>
          <p:nvPr/>
        </p:nvSpPr>
        <p:spPr>
          <a:xfrm rot="16200000">
            <a:off x="-478166" y="1276705"/>
            <a:ext cx="2194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 (Months)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EDFF66D-0F31-F2BD-8EBA-1E7C8967E6EB}"/>
              </a:ext>
            </a:extLst>
          </p:cNvPr>
          <p:cNvSpPr txBox="1"/>
          <p:nvPr/>
        </p:nvSpPr>
        <p:spPr>
          <a:xfrm>
            <a:off x="698427" y="25400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44FA430A-CD12-E941-8EF4-FB7DE061D60A}"/>
              </a:ext>
            </a:extLst>
          </p:cNvPr>
          <p:cNvSpPr txBox="1"/>
          <p:nvPr/>
        </p:nvSpPr>
        <p:spPr>
          <a:xfrm>
            <a:off x="698427" y="644471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489EDC1-57A0-8ADE-8796-5B5CD03D7D49}"/>
              </a:ext>
            </a:extLst>
          </p:cNvPr>
          <p:cNvSpPr txBox="1"/>
          <p:nvPr/>
        </p:nvSpPr>
        <p:spPr>
          <a:xfrm>
            <a:off x="698427" y="1285805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311A6D55-014E-4446-8F28-856CB8C27EED}"/>
              </a:ext>
            </a:extLst>
          </p:cNvPr>
          <p:cNvSpPr txBox="1"/>
          <p:nvPr/>
        </p:nvSpPr>
        <p:spPr>
          <a:xfrm>
            <a:off x="797813" y="1927139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54A36FB-696B-373B-EA51-0455D823CD96}"/>
              </a:ext>
            </a:extLst>
          </p:cNvPr>
          <p:cNvSpPr txBox="1"/>
          <p:nvPr/>
        </p:nvSpPr>
        <p:spPr>
          <a:xfrm>
            <a:off x="847505" y="2561016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9E8025A-2558-6EBC-FB95-14FA41974F12}"/>
              </a:ext>
            </a:extLst>
          </p:cNvPr>
          <p:cNvSpPr txBox="1"/>
          <p:nvPr/>
        </p:nvSpPr>
        <p:spPr>
          <a:xfrm>
            <a:off x="1230703" y="3034216"/>
            <a:ext cx="3009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Progression-Free Survival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Months)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26A7FB13-6115-EB26-6E32-FCDA36599AC3}"/>
              </a:ext>
            </a:extLst>
          </p:cNvPr>
          <p:cNvSpPr txBox="1"/>
          <p:nvPr/>
        </p:nvSpPr>
        <p:spPr>
          <a:xfrm>
            <a:off x="3915950" y="277390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AA184DC-0B2D-A66E-564F-E7ED88717720}"/>
              </a:ext>
            </a:extLst>
          </p:cNvPr>
          <p:cNvSpPr txBox="1"/>
          <p:nvPr/>
        </p:nvSpPr>
        <p:spPr>
          <a:xfrm>
            <a:off x="3171606" y="277390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AED46CBF-8FE4-B5DB-1463-6CF0EBC8D3F0}"/>
              </a:ext>
            </a:extLst>
          </p:cNvPr>
          <p:cNvSpPr txBox="1"/>
          <p:nvPr/>
        </p:nvSpPr>
        <p:spPr>
          <a:xfrm>
            <a:off x="2420809" y="2773907"/>
            <a:ext cx="4828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199E95D9-3AE2-F7A8-DFB4-87D0351E9E3C}"/>
              </a:ext>
            </a:extLst>
          </p:cNvPr>
          <p:cNvSpPr txBox="1"/>
          <p:nvPr/>
        </p:nvSpPr>
        <p:spPr>
          <a:xfrm>
            <a:off x="1738079" y="27739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BA2A887-CC99-318A-E361-B8180763CBD6}"/>
              </a:ext>
            </a:extLst>
          </p:cNvPr>
          <p:cNvSpPr txBox="1"/>
          <p:nvPr/>
        </p:nvSpPr>
        <p:spPr>
          <a:xfrm>
            <a:off x="1011176" y="2773907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477CD620-1925-6B59-0CE2-506B5BE6430F}"/>
              </a:ext>
            </a:extLst>
          </p:cNvPr>
          <p:cNvSpPr txBox="1"/>
          <p:nvPr/>
        </p:nvSpPr>
        <p:spPr>
          <a:xfrm>
            <a:off x="2437568" y="1888550"/>
            <a:ext cx="1744994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earson’s 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= 0.63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8666" t="8522" b="9621"/>
          <a:stretch/>
        </p:blipFill>
        <p:spPr>
          <a:xfrm>
            <a:off x="5605146" y="3354985"/>
            <a:ext cx="3158827" cy="2670072"/>
          </a:xfrm>
          <a:prstGeom prst="rect">
            <a:avLst/>
          </a:prstGeom>
        </p:spPr>
      </p:pic>
      <p:sp>
        <p:nvSpPr>
          <p:cNvPr id="150" name="TextBox 149">
            <a:extLst>
              <a:ext uri="{FF2B5EF4-FFF2-40B4-BE49-F238E27FC236}">
                <a16:creationId xmlns:a16="http://schemas.microsoft.com/office/drawing/2014/main" id="{477CD620-1925-6B59-0CE2-506B5BE6430F}"/>
              </a:ext>
            </a:extLst>
          </p:cNvPr>
          <p:cNvSpPr txBox="1"/>
          <p:nvPr/>
        </p:nvSpPr>
        <p:spPr>
          <a:xfrm>
            <a:off x="6914316" y="5234795"/>
            <a:ext cx="1837659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earson’s R</a:t>
            </a:r>
            <a:r>
              <a:rPr lang="en-US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= 0.25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39E8025A-2558-6EBC-FB95-14FA41974F12}"/>
              </a:ext>
            </a:extLst>
          </p:cNvPr>
          <p:cNvSpPr txBox="1"/>
          <p:nvPr/>
        </p:nvSpPr>
        <p:spPr>
          <a:xfrm>
            <a:off x="5754816" y="6234755"/>
            <a:ext cx="30091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rogression-Free Survival (Months)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EAA184DC-0B2D-A66E-564F-E7ED88717720}"/>
              </a:ext>
            </a:extLst>
          </p:cNvPr>
          <p:cNvSpPr txBox="1"/>
          <p:nvPr/>
        </p:nvSpPr>
        <p:spPr>
          <a:xfrm>
            <a:off x="8369806" y="59566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AED46CBF-8FE4-B5DB-1463-6CF0EBC8D3F0}"/>
              </a:ext>
            </a:extLst>
          </p:cNvPr>
          <p:cNvSpPr txBox="1"/>
          <p:nvPr/>
        </p:nvSpPr>
        <p:spPr>
          <a:xfrm>
            <a:off x="7402425" y="59566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99E95D9-3AE2-F7A8-DFB4-87D0351E9E3C}"/>
              </a:ext>
            </a:extLst>
          </p:cNvPr>
          <p:cNvSpPr txBox="1"/>
          <p:nvPr/>
        </p:nvSpPr>
        <p:spPr>
          <a:xfrm>
            <a:off x="6439511" y="5956622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EBA2A887-CC99-318A-E361-B8180763CBD6}"/>
              </a:ext>
            </a:extLst>
          </p:cNvPr>
          <p:cNvSpPr txBox="1"/>
          <p:nvPr/>
        </p:nvSpPr>
        <p:spPr>
          <a:xfrm>
            <a:off x="5468995" y="5956622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6E825D7-E3CC-9D06-28FB-2D55C6F54C14}"/>
              </a:ext>
            </a:extLst>
          </p:cNvPr>
          <p:cNvSpPr txBox="1"/>
          <p:nvPr/>
        </p:nvSpPr>
        <p:spPr>
          <a:xfrm rot="16200000">
            <a:off x="3956473" y="4506710"/>
            <a:ext cx="2194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verall Survival (Months)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44FA430A-CD12-E941-8EF4-FB7DE061D60A}"/>
              </a:ext>
            </a:extLst>
          </p:cNvPr>
          <p:cNvSpPr txBox="1"/>
          <p:nvPr/>
        </p:nvSpPr>
        <p:spPr>
          <a:xfrm>
            <a:off x="5273087" y="3242706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5489EDC1-57A0-8ADE-8796-5B5CD03D7D49}"/>
              </a:ext>
            </a:extLst>
          </p:cNvPr>
          <p:cNvSpPr txBox="1"/>
          <p:nvPr/>
        </p:nvSpPr>
        <p:spPr>
          <a:xfrm>
            <a:off x="5273087" y="3846107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311A6D55-014E-4446-8F28-856CB8C27EED}"/>
              </a:ext>
            </a:extLst>
          </p:cNvPr>
          <p:cNvSpPr txBox="1"/>
          <p:nvPr/>
        </p:nvSpPr>
        <p:spPr>
          <a:xfrm>
            <a:off x="5273087" y="5156853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154A36FB-696B-373B-EA51-0455D823CD96}"/>
              </a:ext>
            </a:extLst>
          </p:cNvPr>
          <p:cNvSpPr txBox="1"/>
          <p:nvPr/>
        </p:nvSpPr>
        <p:spPr>
          <a:xfrm>
            <a:off x="5322779" y="5795190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311A6D55-014E-4446-8F28-856CB8C27EED}"/>
              </a:ext>
            </a:extLst>
          </p:cNvPr>
          <p:cNvSpPr txBox="1"/>
          <p:nvPr/>
        </p:nvSpPr>
        <p:spPr>
          <a:xfrm>
            <a:off x="5273087" y="4512824"/>
            <a:ext cx="3834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46296" y="1464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E9A96B0-ABE7-B96D-5A74-E617E9F3FD0B}"/>
              </a:ext>
            </a:extLst>
          </p:cNvPr>
          <p:cNvGrpSpPr/>
          <p:nvPr/>
        </p:nvGrpSpPr>
        <p:grpSpPr>
          <a:xfrm>
            <a:off x="4900000" y="-23163"/>
            <a:ext cx="3811439" cy="3320628"/>
            <a:chOff x="446296" y="3164752"/>
            <a:chExt cx="3811439" cy="3320628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D6E825D7-E3CC-9D06-28FB-2D55C6F54C14}"/>
                </a:ext>
              </a:extLst>
            </p:cNvPr>
            <p:cNvSpPr txBox="1"/>
            <p:nvPr/>
          </p:nvSpPr>
          <p:spPr>
            <a:xfrm rot="16200000">
              <a:off x="-490756" y="4456689"/>
              <a:ext cx="2194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Months)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CEDFF66D-0F31-F2BD-8EBA-1E7C8967E6EB}"/>
                </a:ext>
              </a:extLst>
            </p:cNvPr>
            <p:cNvSpPr txBox="1"/>
            <p:nvPr/>
          </p:nvSpPr>
          <p:spPr>
            <a:xfrm>
              <a:off x="698427" y="3205384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44FA430A-CD12-E941-8EF4-FB7DE061D60A}"/>
                </a:ext>
              </a:extLst>
            </p:cNvPr>
            <p:cNvSpPr txBox="1"/>
            <p:nvPr/>
          </p:nvSpPr>
          <p:spPr>
            <a:xfrm>
              <a:off x="698427" y="3824455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5489EDC1-57A0-8ADE-8796-5B5CD03D7D49}"/>
                </a:ext>
              </a:extLst>
            </p:cNvPr>
            <p:cNvSpPr txBox="1"/>
            <p:nvPr/>
          </p:nvSpPr>
          <p:spPr>
            <a:xfrm>
              <a:off x="698427" y="4453089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11A6D55-014E-4446-8F28-856CB8C27EED}"/>
                </a:ext>
              </a:extLst>
            </p:cNvPr>
            <p:cNvSpPr txBox="1"/>
            <p:nvPr/>
          </p:nvSpPr>
          <p:spPr>
            <a:xfrm>
              <a:off x="797813" y="509442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154A36FB-696B-373B-EA51-0455D823CD96}"/>
                </a:ext>
              </a:extLst>
            </p:cNvPr>
            <p:cNvSpPr txBox="1"/>
            <p:nvPr/>
          </p:nvSpPr>
          <p:spPr>
            <a:xfrm>
              <a:off x="847505" y="5702900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39E8025A-2558-6EBC-FB95-14FA41974F12}"/>
                </a:ext>
              </a:extLst>
            </p:cNvPr>
            <p:cNvSpPr txBox="1"/>
            <p:nvPr/>
          </p:nvSpPr>
          <p:spPr>
            <a:xfrm>
              <a:off x="1192092" y="6177603"/>
              <a:ext cx="30091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 (Months)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26A7FB13-6115-EB26-6E32-FCDA36599AC3}"/>
                </a:ext>
              </a:extLst>
            </p:cNvPr>
            <p:cNvSpPr txBox="1"/>
            <p:nvPr/>
          </p:nvSpPr>
          <p:spPr>
            <a:xfrm>
              <a:off x="3774911" y="5899470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AA184DC-0B2D-A66E-564F-E7ED88717720}"/>
                </a:ext>
              </a:extLst>
            </p:cNvPr>
            <p:cNvSpPr txBox="1"/>
            <p:nvPr/>
          </p:nvSpPr>
          <p:spPr>
            <a:xfrm>
              <a:off x="3066354" y="5899470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AED46CBF-8FE4-B5DB-1463-6CF0EBC8D3F0}"/>
                </a:ext>
              </a:extLst>
            </p:cNvPr>
            <p:cNvSpPr txBox="1"/>
            <p:nvPr/>
          </p:nvSpPr>
          <p:spPr>
            <a:xfrm>
              <a:off x="2340959" y="5899470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199E95D9-3AE2-F7A8-DFB4-87D0351E9E3C}"/>
                </a:ext>
              </a:extLst>
            </p:cNvPr>
            <p:cNvSpPr txBox="1"/>
            <p:nvPr/>
          </p:nvSpPr>
          <p:spPr>
            <a:xfrm>
              <a:off x="1709031" y="589947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BA2A887-CC99-318A-E361-B8180763CBD6}"/>
                </a:ext>
              </a:extLst>
            </p:cNvPr>
            <p:cNvSpPr txBox="1"/>
            <p:nvPr/>
          </p:nvSpPr>
          <p:spPr>
            <a:xfrm>
              <a:off x="979818" y="5899470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pic>
          <p:nvPicPr>
            <p:cNvPr id="132" name="Picture 131"/>
            <p:cNvPicPr>
              <a:picLocks noChangeAspect="1"/>
            </p:cNvPicPr>
            <p:nvPr/>
          </p:nvPicPr>
          <p:blipFill rotWithShape="1">
            <a:blip r:embed="rId5"/>
            <a:srcRect l="9369" t="7683" b="9063"/>
            <a:stretch/>
          </p:blipFill>
          <p:spPr>
            <a:xfrm>
              <a:off x="1100310" y="3297834"/>
              <a:ext cx="3118642" cy="2664006"/>
            </a:xfrm>
            <a:prstGeom prst="rect">
              <a:avLst/>
            </a:prstGeom>
          </p:spPr>
        </p:pic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477CD620-1925-6B59-0CE2-506B5BE6430F}"/>
                </a:ext>
              </a:extLst>
            </p:cNvPr>
            <p:cNvSpPr txBox="1"/>
            <p:nvPr/>
          </p:nvSpPr>
          <p:spPr>
            <a:xfrm>
              <a:off x="2392068" y="5177643"/>
              <a:ext cx="1750735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earson’s R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= 0.71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46296" y="316475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charset="0"/>
                  <a:ea typeface="Arial" charset="0"/>
                  <a:cs typeface="Arial" charset="0"/>
                </a:rPr>
                <a:t>B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A59B55ED-F275-58C7-A98B-3FB937163B73}"/>
              </a:ext>
            </a:extLst>
          </p:cNvPr>
          <p:cNvGrpSpPr/>
          <p:nvPr/>
        </p:nvGrpSpPr>
        <p:grpSpPr>
          <a:xfrm>
            <a:off x="353626" y="3195455"/>
            <a:ext cx="4014480" cy="3348271"/>
            <a:chOff x="4880961" y="-6278"/>
            <a:chExt cx="4014480" cy="3348271"/>
          </a:xfrm>
        </p:grpSpPr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D6E825D7-E3CC-9D06-28FB-2D55C6F54C14}"/>
                </a:ext>
              </a:extLst>
            </p:cNvPr>
            <p:cNvSpPr txBox="1"/>
            <p:nvPr/>
          </p:nvSpPr>
          <p:spPr>
            <a:xfrm rot="16200000">
              <a:off x="3939122" y="1276705"/>
              <a:ext cx="2194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 (Months)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CEDFF66D-0F31-F2BD-8EBA-1E7C8967E6EB}"/>
                </a:ext>
              </a:extLst>
            </p:cNvPr>
            <p:cNvSpPr txBox="1"/>
            <p:nvPr/>
          </p:nvSpPr>
          <p:spPr>
            <a:xfrm>
              <a:off x="5173701" y="57192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44FA430A-CD12-E941-8EF4-FB7DE061D60A}"/>
                </a:ext>
              </a:extLst>
            </p:cNvPr>
            <p:cNvSpPr txBox="1"/>
            <p:nvPr/>
          </p:nvSpPr>
          <p:spPr>
            <a:xfrm>
              <a:off x="5273087" y="526560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5489EDC1-57A0-8ADE-8796-5B5CD03D7D49}"/>
                </a:ext>
              </a:extLst>
            </p:cNvPr>
            <p:cNvSpPr txBox="1"/>
            <p:nvPr/>
          </p:nvSpPr>
          <p:spPr>
            <a:xfrm>
              <a:off x="5273087" y="104468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311A6D55-014E-4446-8F28-856CB8C27EED}"/>
                </a:ext>
              </a:extLst>
            </p:cNvPr>
            <p:cNvSpPr txBox="1"/>
            <p:nvPr/>
          </p:nvSpPr>
          <p:spPr>
            <a:xfrm>
              <a:off x="5273087" y="2068771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154A36FB-696B-373B-EA51-0455D823CD96}"/>
                </a:ext>
              </a:extLst>
            </p:cNvPr>
            <p:cNvSpPr txBox="1"/>
            <p:nvPr/>
          </p:nvSpPr>
          <p:spPr>
            <a:xfrm>
              <a:off x="5322779" y="2600063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39E8025A-2558-6EBC-FB95-14FA41974F12}"/>
                </a:ext>
              </a:extLst>
            </p:cNvPr>
            <p:cNvSpPr txBox="1"/>
            <p:nvPr/>
          </p:nvSpPr>
          <p:spPr>
            <a:xfrm>
              <a:off x="5886284" y="3034216"/>
              <a:ext cx="30091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 panose="020B0604020202020204" pitchFamily="34" charset="0"/>
                  <a:cs typeface="Arial" panose="020B0604020202020204" pitchFamily="34" charset="0"/>
                </a:rPr>
                <a:t>Progression-Free Survival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(Months)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26A7FB13-6115-EB26-6E32-FCDA36599AC3}"/>
                </a:ext>
              </a:extLst>
            </p:cNvPr>
            <p:cNvSpPr txBox="1"/>
            <p:nvPr/>
          </p:nvSpPr>
          <p:spPr>
            <a:xfrm>
              <a:off x="8359228" y="277390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EAA184DC-0B2D-A66E-564F-E7ED88717720}"/>
                </a:ext>
              </a:extLst>
            </p:cNvPr>
            <p:cNvSpPr txBox="1"/>
            <p:nvPr/>
          </p:nvSpPr>
          <p:spPr>
            <a:xfrm>
              <a:off x="7636599" y="277390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AED46CBF-8FE4-B5DB-1463-6CF0EBC8D3F0}"/>
                </a:ext>
              </a:extLst>
            </p:cNvPr>
            <p:cNvSpPr txBox="1"/>
            <p:nvPr/>
          </p:nvSpPr>
          <p:spPr>
            <a:xfrm>
              <a:off x="6923218" y="277390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199E95D9-3AE2-F7A8-DFB4-87D0351E9E3C}"/>
                </a:ext>
              </a:extLst>
            </p:cNvPr>
            <p:cNvSpPr txBox="1"/>
            <p:nvPr/>
          </p:nvSpPr>
          <p:spPr>
            <a:xfrm>
              <a:off x="6203419" y="2773907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EBA2A887-CC99-318A-E361-B8180763CBD6}"/>
                </a:ext>
              </a:extLst>
            </p:cNvPr>
            <p:cNvSpPr txBox="1"/>
            <p:nvPr/>
          </p:nvSpPr>
          <p:spPr>
            <a:xfrm>
              <a:off x="5461506" y="2773907"/>
              <a:ext cx="3337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</p:txBody>
        </p:sp>
        <p:pic>
          <p:nvPicPr>
            <p:cNvPr id="145" name="Picture 144"/>
            <p:cNvPicPr>
              <a:picLocks noChangeAspect="1"/>
            </p:cNvPicPr>
            <p:nvPr/>
          </p:nvPicPr>
          <p:blipFill rotWithShape="1">
            <a:blip r:embed="rId6"/>
            <a:srcRect l="9838" t="6762" b="9949"/>
            <a:stretch/>
          </p:blipFill>
          <p:spPr>
            <a:xfrm>
              <a:off x="5618860" y="117554"/>
              <a:ext cx="3133115" cy="2691419"/>
            </a:xfrm>
            <a:prstGeom prst="rect">
              <a:avLst/>
            </a:prstGeom>
          </p:spPr>
        </p:pic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311A6D55-014E-4446-8F28-856CB8C27EED}"/>
                </a:ext>
              </a:extLst>
            </p:cNvPr>
            <p:cNvSpPr txBox="1"/>
            <p:nvPr/>
          </p:nvSpPr>
          <p:spPr>
            <a:xfrm>
              <a:off x="5273087" y="1580773"/>
              <a:ext cx="38343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477CD620-1925-6B59-0CE2-506B5BE6430F}"/>
                </a:ext>
              </a:extLst>
            </p:cNvPr>
            <p:cNvSpPr txBox="1"/>
            <p:nvPr/>
          </p:nvSpPr>
          <p:spPr>
            <a:xfrm>
              <a:off x="6989655" y="1884228"/>
              <a:ext cx="1842286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earson’s R</a:t>
              </a:r>
              <a:r>
                <a:rPr lang="en-US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= 0.39</a:t>
              </a:r>
            </a:p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880961" y="-627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charset="0"/>
                  <a:ea typeface="Arial" charset="0"/>
                  <a:cs typeface="Arial" charset="0"/>
                </a:rPr>
                <a:t>C</a:t>
              </a:r>
            </a:p>
          </p:txBody>
        </p:sp>
      </p:grpSp>
      <p:sp>
        <p:nvSpPr>
          <p:cNvPr id="63" name="TextBox 62"/>
          <p:cNvSpPr txBox="1"/>
          <p:nvPr/>
        </p:nvSpPr>
        <p:spPr>
          <a:xfrm>
            <a:off x="4880961" y="320098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charset="0"/>
                <a:ea typeface="Arial" charset="0"/>
                <a:cs typeface="Arial" charset="0"/>
              </a:rPr>
              <a:t>D</a:t>
            </a:r>
            <a:endParaRPr lang="en-US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528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DC612FB6-827A-7141-82C4-A51403B46646}"/>
              </a:ext>
            </a:extLst>
          </p:cNvPr>
          <p:cNvSpPr/>
          <p:nvPr/>
        </p:nvSpPr>
        <p:spPr>
          <a:xfrm>
            <a:off x="211015" y="205644"/>
            <a:ext cx="8721969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914400">
              <a:defRPr/>
            </a:pPr>
            <a:r>
              <a:rPr lang="en-CA" sz="1800" b="1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upplementary Figure S2. Correlation between CNS-specific</a:t>
            </a:r>
            <a:r>
              <a:rPr lang="en-CA" sz="1800" b="1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800" b="1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gression-free survival and overall survival in the cohort.</a:t>
            </a:r>
            <a:r>
              <a:rPr lang="en-CA" sz="1800" b="1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sz="1800" b="0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A) Correlation between overall survival and CNS-specific progression in</a:t>
            </a:r>
            <a:r>
              <a:rPr lang="en-CA" sz="1800" b="0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patients with documented CNS-specific progression. (B) </a:t>
            </a:r>
            <a:r>
              <a:rPr lang="en-CA" sz="1800" b="0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lation between overall survival and CNS-specific progression in</a:t>
            </a:r>
            <a:r>
              <a:rPr lang="en-CA" sz="1800" b="0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patients with documented CNS-specific progression and death. (C) </a:t>
            </a:r>
            <a:r>
              <a:rPr lang="en-CA" sz="1800" b="0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lation between overall survival and CNS-specific progression in</a:t>
            </a:r>
            <a:r>
              <a:rPr lang="en-CA" sz="1800" b="0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patients with progression caused by causes other than death. (D) </a:t>
            </a:r>
            <a:r>
              <a:rPr lang="en-CA" sz="1800" b="0" kern="120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rrelation between overall survival and CNS-specific progression in</a:t>
            </a:r>
            <a:r>
              <a:rPr lang="en-CA" sz="1800" b="0" kern="1200" baseline="0" noProof="0" dirty="0"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ll patients with progression caused by causes other than death and who had documented death. </a:t>
            </a:r>
            <a:r>
              <a:rPr lang="en-CA" b="0" baseline="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CA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-value calculated by linear regression.</a:t>
            </a:r>
          </a:p>
        </p:txBody>
      </p:sp>
    </p:spTree>
    <p:extLst>
      <p:ext uri="{BB962C8B-B14F-4D97-AF65-F5344CB8AC3E}">
        <p14:creationId xmlns:p14="http://schemas.microsoft.com/office/powerpoint/2010/main" val="122910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8</TotalTime>
  <Words>347</Words>
  <Application>Microsoft Macintosh PowerPoint</Application>
  <PresentationFormat>On-screen Show (4:3)</PresentationFormat>
  <Paragraphs>65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Matthew Dankner</cp:lastModifiedBy>
  <cp:revision>168</cp:revision>
  <dcterms:created xsi:type="dcterms:W3CDTF">2020-04-05T17:20:22Z</dcterms:created>
  <dcterms:modified xsi:type="dcterms:W3CDTF">2023-04-06T19:24:09Z</dcterms:modified>
</cp:coreProperties>
</file>